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361488" cy="6480175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70" d="100"/>
          <a:sy n="170" d="100"/>
        </p:scale>
        <p:origin x="1020" y="1482"/>
      </p:cViewPr>
      <p:guideLst>
        <p:guide orient="horz" pos="2042"/>
        <p:guide pos="294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F6F4EA-5653-4FDF-B4DB-FFE78360FB42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711200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2F1ADB-B6B1-40DB-982A-8AEFF56825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1925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711200" y="744538"/>
            <a:ext cx="5375275" cy="3722687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2F1ADB-B6B1-40DB-982A-8AEFF568258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25723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02112" y="2013062"/>
            <a:ext cx="7957265" cy="138903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04225" y="3672106"/>
            <a:ext cx="6553042" cy="16560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9025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0119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090310" y="346513"/>
            <a:ext cx="1579752" cy="7371199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51061" y="346513"/>
            <a:ext cx="4583229" cy="7371199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0198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7636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39493" y="4164119"/>
            <a:ext cx="7957265" cy="128703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39493" y="2746575"/>
            <a:ext cx="7957265" cy="14175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98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51061" y="2016061"/>
            <a:ext cx="3081489" cy="570165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88577" y="2016061"/>
            <a:ext cx="3081489" cy="570165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1030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8076" y="259508"/>
            <a:ext cx="8425340" cy="108003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8078" y="1450540"/>
            <a:ext cx="4136283" cy="6045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8078" y="2055059"/>
            <a:ext cx="4136283" cy="373360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755514" y="1450540"/>
            <a:ext cx="4137907" cy="6045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755514" y="2055059"/>
            <a:ext cx="4137907" cy="373360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0530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7197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0100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8080" y="258007"/>
            <a:ext cx="3079865" cy="109803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660088" y="258007"/>
            <a:ext cx="5233333" cy="55306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68080" y="1356037"/>
            <a:ext cx="3079865" cy="443262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6659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34919" y="4536129"/>
            <a:ext cx="5616893" cy="53551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834919" y="579022"/>
            <a:ext cx="5616893" cy="38881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834919" y="5071637"/>
            <a:ext cx="5616893" cy="76052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4617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68076" y="259508"/>
            <a:ext cx="8425340" cy="10800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8076" y="1512042"/>
            <a:ext cx="8425340" cy="42766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68076" y="6006169"/>
            <a:ext cx="2184348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B0F14-748C-4F8B-BD69-E78FD312FEEE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98509" y="6006169"/>
            <a:ext cx="2964471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709067" y="6006169"/>
            <a:ext cx="2184348" cy="345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A69B9-C67F-419B-94CA-63AFC6D9853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9479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feld 80"/>
          <p:cNvSpPr txBox="1"/>
          <p:nvPr/>
        </p:nvSpPr>
        <p:spPr>
          <a:xfrm>
            <a:off x="959779" y="843887"/>
            <a:ext cx="2972917" cy="43088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21,330  Participant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EPIC study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recruited 1992-2000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959596" y="1810561"/>
            <a:ext cx="2973102" cy="26161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87,889 Participants</a:t>
            </a:r>
          </a:p>
        </p:txBody>
      </p:sp>
      <p:cxnSp>
        <p:nvCxnSpPr>
          <p:cNvPr id="85" name="Gerade Verbindung mit Pfeil 84"/>
          <p:cNvCxnSpPr>
            <a:stCxn id="81" idx="2"/>
            <a:endCxn id="84" idx="0"/>
          </p:cNvCxnSpPr>
          <p:nvPr/>
        </p:nvCxnSpPr>
        <p:spPr>
          <a:xfrm flipH="1">
            <a:off x="2446147" y="1274774"/>
            <a:ext cx="91" cy="535787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feld 86"/>
          <p:cNvSpPr txBox="1"/>
          <p:nvPr/>
        </p:nvSpPr>
        <p:spPr>
          <a:xfrm>
            <a:off x="4471106" y="1239147"/>
            <a:ext cx="1937830" cy="600164"/>
          </a:xfrm>
          <a:prstGeom prst="rect">
            <a:avLst/>
          </a:prstGeom>
          <a:solidFill>
            <a:schemeClr val="accent1">
              <a:lumMod val="20000"/>
              <a:lumOff val="80000"/>
              <a:alpha val="34000"/>
            </a:schemeClr>
          </a:solidFill>
          <a:ln w="9525">
            <a:solidFill>
              <a:schemeClr val="tx1"/>
            </a:solidFill>
            <a:prstDash val="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clusions: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33,441 Participants</a:t>
            </a:r>
            <a:b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thout Blood Collec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Gerade Verbindung mit Pfeil 87"/>
          <p:cNvCxnSpPr>
            <a:endCxn id="87" idx="1"/>
          </p:cNvCxnSpPr>
          <p:nvPr/>
        </p:nvCxnSpPr>
        <p:spPr>
          <a:xfrm flipV="1">
            <a:off x="2446238" y="1539229"/>
            <a:ext cx="2024868" cy="3439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959596" y="2515048"/>
            <a:ext cx="2973100" cy="60016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,235 Participants  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a Convenient Sample of Controls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without Major Chronic Diseases)</a:t>
            </a:r>
          </a:p>
        </p:txBody>
      </p:sp>
      <p:cxnSp>
        <p:nvCxnSpPr>
          <p:cNvPr id="26" name="Gerade Verbindung mit Pfeil 25"/>
          <p:cNvCxnSpPr>
            <a:stCxn id="84" idx="2"/>
            <a:endCxn id="25" idx="0"/>
          </p:cNvCxnSpPr>
          <p:nvPr/>
        </p:nvCxnSpPr>
        <p:spPr>
          <a:xfrm flipH="1">
            <a:off x="2446146" y="2072171"/>
            <a:ext cx="1" cy="442877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959595" y="3641088"/>
            <a:ext cx="2973103" cy="26161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,174 Participants</a:t>
            </a:r>
          </a:p>
        </p:txBody>
      </p:sp>
      <p:cxnSp>
        <p:nvCxnSpPr>
          <p:cNvPr id="28" name="Gerade Verbindung mit Pfeil 27"/>
          <p:cNvCxnSpPr>
            <a:stCxn id="25" idx="2"/>
            <a:endCxn id="27" idx="0"/>
          </p:cNvCxnSpPr>
          <p:nvPr/>
        </p:nvCxnSpPr>
        <p:spPr>
          <a:xfrm>
            <a:off x="2446146" y="3115212"/>
            <a:ext cx="1" cy="525876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959595" y="4444814"/>
            <a:ext cx="2973101" cy="26161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15 Participants</a:t>
            </a:r>
          </a:p>
        </p:txBody>
      </p:sp>
      <p:cxnSp>
        <p:nvCxnSpPr>
          <p:cNvPr id="41" name="Gerade Verbindung mit Pfeil 40"/>
          <p:cNvCxnSpPr>
            <a:stCxn id="27" idx="2"/>
            <a:endCxn id="40" idx="0"/>
          </p:cNvCxnSpPr>
          <p:nvPr/>
        </p:nvCxnSpPr>
        <p:spPr>
          <a:xfrm flipH="1">
            <a:off x="2446146" y="3902698"/>
            <a:ext cx="1" cy="542116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/>
          <p:cNvSpPr txBox="1"/>
          <p:nvPr/>
        </p:nvSpPr>
        <p:spPr>
          <a:xfrm>
            <a:off x="4471104" y="3062871"/>
            <a:ext cx="2406774" cy="600164"/>
          </a:xfrm>
          <a:prstGeom prst="rect">
            <a:avLst/>
          </a:prstGeom>
          <a:solidFill>
            <a:schemeClr val="accent1">
              <a:lumMod val="20000"/>
              <a:lumOff val="80000"/>
              <a:alpha val="34000"/>
            </a:schemeClr>
          </a:solidFill>
          <a:ln w="9525">
            <a:solidFill>
              <a:schemeClr val="tx1"/>
            </a:solidFill>
            <a:prstDash val="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clusions: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,061 Participants</a:t>
            </a:r>
            <a:b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thout CRP Measurement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4471104" y="3877113"/>
            <a:ext cx="2406774" cy="600164"/>
          </a:xfrm>
          <a:prstGeom prst="rect">
            <a:avLst/>
          </a:prstGeom>
          <a:solidFill>
            <a:schemeClr val="accent1">
              <a:lumMod val="20000"/>
              <a:lumOff val="80000"/>
              <a:alpha val="34000"/>
            </a:schemeClr>
          </a:solidFill>
          <a:ln w="9525">
            <a:solidFill>
              <a:schemeClr val="tx1"/>
            </a:solidFill>
            <a:prstDash val="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clusions: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859 Participants</a:t>
            </a:r>
            <a:b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thout Polyphenol Measurement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Gerade Verbindung mit Pfeil 50"/>
          <p:cNvCxnSpPr/>
          <p:nvPr/>
        </p:nvCxnSpPr>
        <p:spPr>
          <a:xfrm flipV="1">
            <a:off x="2447193" y="3373194"/>
            <a:ext cx="2024868" cy="3439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 flipV="1">
            <a:off x="2448239" y="4173756"/>
            <a:ext cx="2024868" cy="3439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hteck 16"/>
          <p:cNvSpPr/>
          <p:nvPr/>
        </p:nvSpPr>
        <p:spPr>
          <a:xfrm>
            <a:off x="360264" y="5688359"/>
            <a:ext cx="18586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65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По избор</PresentationFormat>
  <Paragraphs>16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лавия на слайдовете</vt:lpstr>
      </vt:variant>
      <vt:variant>
        <vt:i4>1</vt:i4>
      </vt:variant>
    </vt:vector>
  </HeadingPairs>
  <TitlesOfParts>
    <vt:vector size="2" baseType="lpstr">
      <vt:lpstr>Larissa</vt:lpstr>
      <vt:lpstr>Презентация на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andart</dc:creator>
  <cp:lastModifiedBy>ACER</cp:lastModifiedBy>
  <cp:revision>69</cp:revision>
  <cp:lastPrinted>2017-07-24T17:01:53Z</cp:lastPrinted>
  <dcterms:created xsi:type="dcterms:W3CDTF">2017-06-28T15:49:48Z</dcterms:created>
  <dcterms:modified xsi:type="dcterms:W3CDTF">2019-08-30T05:30:15Z</dcterms:modified>
</cp:coreProperties>
</file>